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75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1CBA48-F991-4246-B226-BA0519C8863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03DD557-2A7E-449C-9F2B-45D4C7A7842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0CD2DF-9D14-46D6-AE95-287FDF88B7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B1663-38CB-40B5-B7FB-B86BA2D58451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8FB4FF-15DA-4BF1-BFE4-36A96C3EDB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18F5AE-41E0-4B82-8707-3D2EE3832B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F358F-A6F3-4034-B854-A8CB85DB5D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78378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5379D5-EC02-4216-BA33-D146222CA4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F6C0A56-BBFC-4C66-9E67-2907F893E7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ECAE8F-5035-48C2-8E6F-02CED79FD7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B1663-38CB-40B5-B7FB-B86BA2D58451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715FE9-4CC9-46E6-BACB-F19DE0F528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423BD6-138F-4D44-B0E5-94FF0E821E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F358F-A6F3-4034-B854-A8CB85DB5D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84970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B0D8247-7D34-4627-B458-5BB59AE4D76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21692F6-0855-470B-9558-7111E36864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852514-F1B5-40DE-A83D-941BA716EC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B1663-38CB-40B5-B7FB-B86BA2D58451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0EEC21-8A36-47D1-92C7-B58BE5178A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A58DA3-A053-4E96-B17C-EB63E0EDB9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F358F-A6F3-4034-B854-A8CB85DB5D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59062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DF0246-A63B-4E51-B83A-F82A228327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F53CC13-8758-4110-B1E7-AE1798432D3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785F83-292D-4A0A-9AA4-A28D2D67E6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B1663-38CB-40B5-B7FB-B86BA2D58451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784C87-2A38-483F-8400-2520660DC4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214C7B-22A9-46E5-A145-A5A56C5454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F358F-A6F3-4034-B854-A8CB85DB5D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98379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D05198-5352-43DC-B157-13127B22FF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6D3895-707D-4D67-A796-6686F8570F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F60018-F935-4D82-A8F0-209C168E8D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B1663-38CB-40B5-B7FB-B86BA2D58451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A35285-4815-4097-8CBC-8715799046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80B7C6-0511-42D6-9530-AB5AFFCC65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F358F-A6F3-4034-B854-A8CB85DB5D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6702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F053C1-3539-4D55-A8B6-01144DD9EA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0AB564-F5E2-4C40-A621-0192BD7DD6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206DA2B-E33B-4E13-862E-4B8B692AC6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D81D9BD-31AC-4262-842F-A4D4627F6D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B1663-38CB-40B5-B7FB-B86BA2D58451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93FB79-02B4-4274-83D7-E31D936300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2164B4B-B583-48B5-BEA5-6F3E8B00E2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F358F-A6F3-4034-B854-A8CB85DB5D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1593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6BB52D-15A4-4A2B-AA49-C3C0AAF95E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64CBFD-49D6-497D-B3B1-B4CFF6ED78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E8C4EBB-A549-4C14-8950-DDB274F901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1180E48-E93B-4A64-B5E0-A56F9E0A02C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4EF05CF-5A79-4137-A553-7A2053D5125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D9C9B1D-C0D1-4C8E-A293-5B0146CDCE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B1663-38CB-40B5-B7FB-B86BA2D58451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89FAD42-37CA-436B-9D17-90DDFC97A9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5CCA6C7-BC03-47B9-8C05-06E2C5C655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F358F-A6F3-4034-B854-A8CB85DB5D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03561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28D533-BAE6-4D1A-A36C-2367ABAE25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87C4E08-75E6-41E3-B752-E3603DCF35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B1663-38CB-40B5-B7FB-B86BA2D58451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03FA6E3-F33C-46AE-B651-A376C62550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57E4ACF-0BB7-4857-8E7F-9E59277BA8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F358F-A6F3-4034-B854-A8CB85DB5D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43005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A110144-A864-435E-8B9E-857814201D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B1663-38CB-40B5-B7FB-B86BA2D58451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DE9B253-7067-488B-85CF-A7C3077590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ED840E1-6D52-42FA-B36D-995B6000C2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F358F-A6F3-4034-B854-A8CB85DB5D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09198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B8FDE7-0A70-4399-AE0E-FFABE956C2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21448F-046A-4E99-942A-69A93943CB4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2463397-3C29-4720-9F7E-7CF510E035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B266D9F-1B5E-444D-9EB1-288A65D6B8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B1663-38CB-40B5-B7FB-B86BA2D58451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59C3AB-0103-4EE2-A160-326025A983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6D21FF-061B-4DEF-B01B-96A480533F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F358F-A6F3-4034-B854-A8CB85DB5D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45923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320F06-77D6-4AD6-81FB-53085A98B3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1F7285F-0E9D-46D0-AA06-B75D9F61D3A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1CE2D9-46E9-46ED-8152-147DF2F0DC0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EA9C425-8099-48C1-868F-87EA34CAF3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BB1663-38CB-40B5-B7FB-B86BA2D58451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E77760-066F-4F14-B976-2408A66E88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BD60BDB-4B1E-43EB-8F4C-3ECD8BAE55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F358F-A6F3-4034-B854-A8CB85DB5D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86293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FD4B0F4-E721-4A1A-8EA3-811BB2A669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93F1AF-6B3B-47EA-85D9-34044C70BB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193C26-9B1D-47C3-913C-94E2E848D55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BB1663-38CB-40B5-B7FB-B86BA2D58451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4DAA28-3F80-4A0A-AC2B-190A5296B37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9641D0-E99D-4F09-8A43-530A7CBE344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6F358F-A6F3-4034-B854-A8CB85DB5D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88201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4735DBC-2404-4A08-B5F0-FCAECE507B6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01229" y="1121864"/>
            <a:ext cx="4623607" cy="2853175"/>
          </a:xfrm>
          <a:prstGeom prst="rect">
            <a:avLst/>
          </a:prstGeom>
        </p:spPr>
      </p:pic>
      <p:sp>
        <p:nvSpPr>
          <p:cNvPr id="49" name="TextBox 48">
            <a:extLst>
              <a:ext uri="{FF2B5EF4-FFF2-40B4-BE49-F238E27FC236}">
                <a16:creationId xmlns:a16="http://schemas.microsoft.com/office/drawing/2014/main" id="{E9F29ACA-F599-423C-8693-7DB9F54FBAE9}"/>
              </a:ext>
            </a:extLst>
          </p:cNvPr>
          <p:cNvSpPr txBox="1"/>
          <p:nvPr/>
        </p:nvSpPr>
        <p:spPr>
          <a:xfrm>
            <a:off x="2122141" y="4164648"/>
            <a:ext cx="7947718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Palatino Linotype" panose="02040502050505030304" pitchFamily="18" charset="0"/>
              </a:rPr>
              <a:t>Figure S1: </a:t>
            </a:r>
            <a:r>
              <a:rPr lang="en-US" sz="1400" dirty="0">
                <a:latin typeface="Palatino Linotype" panose="02040502050505030304" pitchFamily="18" charset="0"/>
              </a:rPr>
              <a:t>Analysis of splicing efficiency in the </a:t>
            </a:r>
            <a:r>
              <a:rPr lang="en-US" sz="1400" i="1" dirty="0">
                <a:latin typeface="Palatino Linotype" panose="02040502050505030304" pitchFamily="18" charset="0"/>
              </a:rPr>
              <a:t>saf5</a:t>
            </a:r>
            <a:r>
              <a:rPr lang="en-US" sz="1400" i="1" dirty="0">
                <a:latin typeface="Symbol" panose="05050102010706020507" pitchFamily="18" charset="2"/>
              </a:rPr>
              <a:t>D</a:t>
            </a:r>
            <a:r>
              <a:rPr lang="en-US" sz="1400" dirty="0">
                <a:latin typeface="Palatino Linotype" panose="02040502050505030304" pitchFamily="18" charset="0"/>
              </a:rPr>
              <a:t> mutant. Spliced mRNAs (smaller PCR products of particular genes) and unspliced pre-mRNAs (larger PCR products of particular genes) are marked with asterisks. Changes in amounts of unspliced pre-mRNAs for the analyzed genes were quantified using ImageJ software and are expressed as the ratio of spliced mRNA to total mRNA (spliced mRNA plus unspliced pre-mRNA). Primers for RT-PCR are listed in Table S1.</a:t>
            </a:r>
            <a:endParaRPr lang="en-GB" sz="14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477766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</TotalTime>
  <Words>81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Symbo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bos Cipak</dc:creator>
  <cp:lastModifiedBy>Lubos Cipak</cp:lastModifiedBy>
  <cp:revision>10</cp:revision>
  <dcterms:created xsi:type="dcterms:W3CDTF">2024-03-26T07:11:13Z</dcterms:created>
  <dcterms:modified xsi:type="dcterms:W3CDTF">2024-03-26T14:02:07Z</dcterms:modified>
</cp:coreProperties>
</file>